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21674138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6" d="100"/>
          <a:sy n="36" d="100"/>
        </p:scale>
        <p:origin x="3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05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5291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658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8498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429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48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20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67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192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481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451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E4568-5ACD-435D-8C4D-5A025A52F662}" type="datetimeFigureOut">
              <a:rPr lang="en-GB" smtClean="0"/>
              <a:t>19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000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923217" y="2238151"/>
            <a:ext cx="2725945" cy="4422915"/>
            <a:chOff x="5152173" y="2270880"/>
            <a:chExt cx="2725945" cy="4422915"/>
          </a:xfrm>
        </p:grpSpPr>
        <p:sp>
          <p:nvSpPr>
            <p:cNvPr id="152" name="TextBox 151"/>
            <p:cNvSpPr txBox="1"/>
            <p:nvPr/>
          </p:nvSpPr>
          <p:spPr>
            <a:xfrm>
              <a:off x="5415801" y="5049878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 flipH="1">
              <a:off x="5415801" y="4477730"/>
              <a:ext cx="5815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 flipH="1">
              <a:off x="5415801" y="3905582"/>
              <a:ext cx="5615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 flipH="1">
              <a:off x="5415801" y="3311731"/>
              <a:ext cx="7635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 rot="16200000">
              <a:off x="4099642" y="3862270"/>
              <a:ext cx="24128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here forming frequency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3" name="Picture 112"/>
            <p:cNvPicPr>
              <a:picLocks noChangeAspect="1"/>
            </p:cNvPicPr>
            <p:nvPr/>
          </p:nvPicPr>
          <p:blipFill rotWithShape="1">
            <a:blip r:embed="rId2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13" r="55232" b="34076"/>
            <a:stretch/>
          </p:blipFill>
          <p:spPr>
            <a:xfrm>
              <a:off x="5804340" y="2270880"/>
              <a:ext cx="1872933" cy="3047802"/>
            </a:xfrm>
            <a:prstGeom prst="rect">
              <a:avLst/>
            </a:prstGeom>
          </p:spPr>
        </p:pic>
        <p:sp>
          <p:nvSpPr>
            <p:cNvPr id="117" name="TextBox 116"/>
            <p:cNvSpPr txBox="1"/>
            <p:nvPr/>
          </p:nvSpPr>
          <p:spPr>
            <a:xfrm flipH="1">
              <a:off x="5415801" y="2707029"/>
              <a:ext cx="7635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 rot="-4200000">
              <a:off x="5477860" y="5646447"/>
              <a:ext cx="1069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treated </a:t>
              </a:r>
              <a:endParaRPr lang="en-GB" sz="1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 rot="-4200000">
              <a:off x="5761645" y="5835226"/>
              <a:ext cx="1409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 rot="-4200000">
              <a:off x="6388311" y="5847544"/>
              <a:ext cx="1321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i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X19</a:t>
              </a:r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iRNA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6214136" y="2809739"/>
              <a:ext cx="16639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ERA2 siRNA A</a:t>
              </a:r>
              <a:endParaRPr lang="en-GB" sz="1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2134153" y="2556355"/>
            <a:ext cx="2690203" cy="4122038"/>
            <a:chOff x="1923754" y="2596502"/>
            <a:chExt cx="2690203" cy="4122038"/>
          </a:xfrm>
        </p:grpSpPr>
        <p:pic>
          <p:nvPicPr>
            <p:cNvPr id="103" name="Picture 102"/>
            <p:cNvPicPr>
              <a:picLocks noChangeAspect="1"/>
            </p:cNvPicPr>
            <p:nvPr/>
          </p:nvPicPr>
          <p:blipFill rotWithShape="1"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86" b="36371"/>
            <a:stretch/>
          </p:blipFill>
          <p:spPr>
            <a:xfrm>
              <a:off x="2635091" y="2596502"/>
              <a:ext cx="1755385" cy="2768864"/>
            </a:xfrm>
            <a:prstGeom prst="rect">
              <a:avLst/>
            </a:prstGeom>
          </p:spPr>
        </p:pic>
        <p:sp>
          <p:nvSpPr>
            <p:cNvPr id="143" name="TextBox 142"/>
            <p:cNvSpPr txBox="1"/>
            <p:nvPr/>
          </p:nvSpPr>
          <p:spPr>
            <a:xfrm rot="-4200000">
              <a:off x="3184680" y="5814487"/>
              <a:ext cx="1321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i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X19</a:t>
              </a:r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iRNA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 rot="-4200000">
              <a:off x="2590043" y="5859971"/>
              <a:ext cx="1409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 rot="-4200000">
              <a:off x="2307623" y="5700300"/>
              <a:ext cx="1069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treated </a:t>
              </a:r>
              <a:endParaRPr lang="en-GB" sz="1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2243074" y="4646283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2239976" y="3223027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2243128" y="2786297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2239976" y="4171403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239976" y="3696523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2241093" y="5103731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 rot="16200000">
              <a:off x="871223" y="3862271"/>
              <a:ext cx="24128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here forming frequency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3079819" y="2809739"/>
              <a:ext cx="15341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W480 siRNA B</a:t>
              </a:r>
              <a:endParaRPr lang="en-GB" sz="1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4" name="TextBox 103"/>
          <p:cNvSpPr txBox="1"/>
          <p:nvPr/>
        </p:nvSpPr>
        <p:spPr>
          <a:xfrm>
            <a:off x="4103208" y="4800223"/>
            <a:ext cx="389381" cy="4893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*</a:t>
            </a:r>
            <a:endParaRPr lang="es-ES" sz="1200" dirty="0"/>
          </a:p>
        </p:txBody>
      </p:sp>
      <p:sp>
        <p:nvSpPr>
          <p:cNvPr id="114" name="TextBox 113"/>
          <p:cNvSpPr txBox="1"/>
          <p:nvPr/>
        </p:nvSpPr>
        <p:spPr>
          <a:xfrm>
            <a:off x="7854761" y="4778559"/>
            <a:ext cx="404946" cy="5654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*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3652851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9</TotalTime>
  <Words>35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ryfysgol Bangor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say McFarlane</dc:creator>
  <cp:lastModifiedBy>Ramsay McFarlane</cp:lastModifiedBy>
  <cp:revision>37</cp:revision>
  <cp:lastPrinted>2016-09-21T13:19:31Z</cp:lastPrinted>
  <dcterms:created xsi:type="dcterms:W3CDTF">2016-08-11T08:24:58Z</dcterms:created>
  <dcterms:modified xsi:type="dcterms:W3CDTF">2017-01-19T15:07:32Z</dcterms:modified>
</cp:coreProperties>
</file>